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906000" type="A4"/>
  <p:notesSz cx="9929813" cy="67992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9" d="100"/>
          <a:sy n="89" d="100"/>
        </p:scale>
        <p:origin x="34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F5D98-1E78-469A-B5AF-59A8DE846F3C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0733-783F-4B9D-B882-E6771296B5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2125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F5D98-1E78-469A-B5AF-59A8DE846F3C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0733-783F-4B9D-B882-E6771296B5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9904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F5D98-1E78-469A-B5AF-59A8DE846F3C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0733-783F-4B9D-B882-E6771296B5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7553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F5D98-1E78-469A-B5AF-59A8DE846F3C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0733-783F-4B9D-B882-E6771296B5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23161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F5D98-1E78-469A-B5AF-59A8DE846F3C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0733-783F-4B9D-B882-E6771296B5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8885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F5D98-1E78-469A-B5AF-59A8DE846F3C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0733-783F-4B9D-B882-E6771296B5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022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F5D98-1E78-469A-B5AF-59A8DE846F3C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0733-783F-4B9D-B882-E6771296B5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4932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F5D98-1E78-469A-B5AF-59A8DE846F3C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0733-783F-4B9D-B882-E6771296B5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8268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F5D98-1E78-469A-B5AF-59A8DE846F3C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0733-783F-4B9D-B882-E6771296B5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0530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F5D98-1E78-469A-B5AF-59A8DE846F3C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0733-783F-4B9D-B882-E6771296B5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6237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F5D98-1E78-469A-B5AF-59A8DE846F3C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0733-783F-4B9D-B882-E6771296B5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9984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F5D98-1E78-469A-B5AF-59A8DE846F3C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850733-783F-4B9D-B882-E6771296B5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150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97873" y="303441"/>
            <a:ext cx="5915025" cy="490717"/>
          </a:xfrm>
        </p:spPr>
        <p:txBody>
          <a:bodyPr>
            <a:normAutofit/>
          </a:bodyPr>
          <a:lstStyle/>
          <a:p>
            <a:r>
              <a:rPr lang="fr-FR" sz="1400" b="1" dirty="0"/>
              <a:t>Figure S2</a:t>
            </a:r>
          </a:p>
        </p:txBody>
      </p:sp>
      <p:sp>
        <p:nvSpPr>
          <p:cNvPr id="175" name="ZoneTexte 174"/>
          <p:cNvSpPr txBox="1"/>
          <p:nvPr/>
        </p:nvSpPr>
        <p:spPr>
          <a:xfrm>
            <a:off x="5205757" y="416001"/>
            <a:ext cx="15093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/>
              <a:t>DAVID et al.</a:t>
            </a:r>
          </a:p>
        </p:txBody>
      </p:sp>
      <p:sp>
        <p:nvSpPr>
          <p:cNvPr id="176" name="ZoneTexte 175">
            <a:extLst>
              <a:ext uri="{FF2B5EF4-FFF2-40B4-BE49-F238E27FC236}">
                <a16:creationId xmlns:a16="http://schemas.microsoft.com/office/drawing/2014/main" id="{D749BD80-BF65-4C41-8281-EB7BD8D19F3D}"/>
              </a:ext>
            </a:extLst>
          </p:cNvPr>
          <p:cNvSpPr txBox="1"/>
          <p:nvPr/>
        </p:nvSpPr>
        <p:spPr>
          <a:xfrm>
            <a:off x="291082" y="5304688"/>
            <a:ext cx="5439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c</a:t>
            </a:r>
          </a:p>
        </p:txBody>
      </p:sp>
      <p:sp>
        <p:nvSpPr>
          <p:cNvPr id="177" name="ZoneTexte 176">
            <a:extLst>
              <a:ext uri="{FF2B5EF4-FFF2-40B4-BE49-F238E27FC236}">
                <a16:creationId xmlns:a16="http://schemas.microsoft.com/office/drawing/2014/main" id="{D749BD80-BF65-4C41-8281-EB7BD8D19F3D}"/>
              </a:ext>
            </a:extLst>
          </p:cNvPr>
          <p:cNvSpPr txBox="1"/>
          <p:nvPr/>
        </p:nvSpPr>
        <p:spPr>
          <a:xfrm>
            <a:off x="298489" y="1451999"/>
            <a:ext cx="5439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a</a:t>
            </a:r>
          </a:p>
        </p:txBody>
      </p:sp>
      <p:sp>
        <p:nvSpPr>
          <p:cNvPr id="179" name="ZoneTexte 178">
            <a:extLst>
              <a:ext uri="{FF2B5EF4-FFF2-40B4-BE49-F238E27FC236}">
                <a16:creationId xmlns:a16="http://schemas.microsoft.com/office/drawing/2014/main" id="{D749BD80-BF65-4C41-8281-EB7BD8D19F3D}"/>
              </a:ext>
            </a:extLst>
          </p:cNvPr>
          <p:cNvSpPr txBox="1"/>
          <p:nvPr/>
        </p:nvSpPr>
        <p:spPr>
          <a:xfrm>
            <a:off x="3322821" y="1448233"/>
            <a:ext cx="5439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b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BC7D826E-0BE7-7F56-54F1-220DA9304569}"/>
              </a:ext>
            </a:extLst>
          </p:cNvPr>
          <p:cNvPicPr/>
          <p:nvPr/>
        </p:nvPicPr>
        <p:blipFill>
          <a:blip r:embed="rId2"/>
          <a:stretch/>
        </p:blipFill>
        <p:spPr>
          <a:xfrm>
            <a:off x="3404822" y="1881152"/>
            <a:ext cx="2798437" cy="4045680"/>
          </a:xfrm>
          <a:prstGeom prst="rect">
            <a:avLst/>
          </a:prstGeom>
          <a:ln w="0">
            <a:noFill/>
          </a:ln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10225CF9-99FA-4BDE-A4C1-1A54E2062C9F}"/>
              </a:ext>
            </a:extLst>
          </p:cNvPr>
          <p:cNvPicPr/>
          <p:nvPr/>
        </p:nvPicPr>
        <p:blipFill>
          <a:blip r:embed="rId3"/>
          <a:stretch/>
        </p:blipFill>
        <p:spPr>
          <a:xfrm>
            <a:off x="318632" y="1881152"/>
            <a:ext cx="2798437" cy="4045680"/>
          </a:xfrm>
          <a:prstGeom prst="rect">
            <a:avLst/>
          </a:prstGeom>
          <a:ln w="0">
            <a:noFill/>
          </a:ln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33AD4AA5-B7CF-4CEF-8419-CB65741AD17D}"/>
              </a:ext>
            </a:extLst>
          </p:cNvPr>
          <p:cNvSpPr txBox="1"/>
          <p:nvPr/>
        </p:nvSpPr>
        <p:spPr>
          <a:xfrm>
            <a:off x="704236" y="6335023"/>
            <a:ext cx="5508662" cy="9534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300"/>
              </a:lnSpc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Figure S2 : mRNA enrichment in polysomes of tm-treated versus untreated cells, with or without MRPS15 immunoprecipitation.</a:t>
            </a:r>
            <a:r>
              <a:rPr lang="fr-FR" sz="900" b="1" dirty="0">
                <a:effectLst/>
                <a:latin typeface="Palatino" pitchFamily="2" charset="77"/>
                <a:ea typeface="Palatino" pitchFamily="2" charset="77"/>
              </a:rPr>
              <a:t> </a:t>
            </a:r>
            <a:endParaRPr lang="fr-FR" sz="900" b="1" dirty="0">
              <a:solidFill>
                <a:srgbClr val="000000"/>
              </a:solidFill>
              <a:effectLst/>
              <a:latin typeface="Palatino" pitchFamily="2" charset="77"/>
              <a:ea typeface="Palatino" pitchFamily="2" charset="77"/>
              <a:cs typeface="Times New Roman" panose="02020603050405020304" pitchFamily="18" charset="0"/>
            </a:endParaRPr>
          </a:p>
          <a:p>
            <a:pPr lvl="0" algn="just">
              <a:lnSpc>
                <a:spcPts val="1300"/>
              </a:lnSpc>
            </a:pPr>
            <a:r>
              <a:rPr lang="en-US" sz="9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mRNA fold change of input (a) or MRPS15 elution (b) samples were compared between treated (tm) and untreated (NT) condition and represented in histograms. Data represent at least 3 independent biological replicates for each condition; </a:t>
            </a:r>
            <a:r>
              <a:rPr lang="en-US" sz="9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</a:rPr>
              <a:t>*p&lt;0.05, **p&lt;0.01, ***p&lt;0.001, ****p&lt;0.0001.</a:t>
            </a:r>
            <a:r>
              <a:rPr lang="fr-FR" sz="900" dirty="0">
                <a:effectLst/>
                <a:latin typeface="Palatino" pitchFamily="2" charset="77"/>
                <a:ea typeface="Palatino" pitchFamily="2" charset="77"/>
              </a:rPr>
              <a:t> </a:t>
            </a:r>
            <a:endParaRPr lang="fr-FR" sz="900" dirty="0">
              <a:solidFill>
                <a:srgbClr val="000000"/>
              </a:solidFill>
              <a:effectLst/>
              <a:latin typeface="Palatino" pitchFamily="2" charset="77"/>
              <a:ea typeface="Palatino" pitchFamily="2" charset="7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497847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8</TotalTime>
  <Words>93</Words>
  <Application>Microsoft Macintosh PowerPoint</Application>
  <PresentationFormat>Format A4 (210 x 297 mm)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</vt:lpstr>
      <vt:lpstr>Thème Office</vt:lpstr>
      <vt:lpstr>Figure S2</vt:lpstr>
    </vt:vector>
  </TitlesOfParts>
  <Company>Inser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lorian David</dc:creator>
  <cp:lastModifiedBy>pratsac@gmail.com</cp:lastModifiedBy>
  <cp:revision>34</cp:revision>
  <cp:lastPrinted>2021-11-30T16:21:26Z</cp:lastPrinted>
  <dcterms:created xsi:type="dcterms:W3CDTF">2021-11-30T15:42:53Z</dcterms:created>
  <dcterms:modified xsi:type="dcterms:W3CDTF">2024-03-06T18:58:28Z</dcterms:modified>
</cp:coreProperties>
</file>